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56" r:id="rId5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64" autoAdjust="0"/>
    <p:restoredTop sz="88986" autoAdjust="0"/>
  </p:normalViewPr>
  <p:slideViewPr>
    <p:cSldViewPr snapToGrid="0">
      <p:cViewPr varScale="1">
        <p:scale>
          <a:sx n="91" d="100"/>
          <a:sy n="91" d="100"/>
        </p:scale>
        <p:origin x="80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8AA64E-6C56-46B0-B097-B667502B1E73}" type="datetimeFigureOut">
              <a:rPr lang="es-ES" smtClean="0"/>
              <a:t>09/09/2021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0B9B76-8A31-4B1D-8D31-2B909C137D5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0981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Table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2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actome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alysis of the proteins from in table 1. p-values are corrected for the multiple testing (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njamini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Hochberg procedure) (see material and methods) FDR, False discovery rate.</a:t>
            </a:r>
            <a:endParaRPr lang="es-E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0B9B76-8A31-4B1D-8D31-2B909C137D58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9120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C2006-A67E-4427-9C0A-76134B0D9FDB}" type="datetimeFigureOut">
              <a:rPr lang="es-ES" smtClean="0"/>
              <a:t>09/09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7CB82-52F1-45D7-918B-22DDAB191B7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7570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C2006-A67E-4427-9C0A-76134B0D9FDB}" type="datetimeFigureOut">
              <a:rPr lang="es-ES" smtClean="0"/>
              <a:t>09/09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7CB82-52F1-45D7-918B-22DDAB191B7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26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C2006-A67E-4427-9C0A-76134B0D9FDB}" type="datetimeFigureOut">
              <a:rPr lang="es-ES" smtClean="0"/>
              <a:t>09/09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7CB82-52F1-45D7-918B-22DDAB191B7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79705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C2006-A67E-4427-9C0A-76134B0D9FDB}" type="datetimeFigureOut">
              <a:rPr lang="es-ES" smtClean="0"/>
              <a:t>09/09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7CB82-52F1-45D7-918B-22DDAB191B7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894762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C2006-A67E-4427-9C0A-76134B0D9FDB}" type="datetimeFigureOut">
              <a:rPr lang="es-ES" smtClean="0"/>
              <a:t>09/09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7CB82-52F1-45D7-918B-22DDAB191B7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6482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C2006-A67E-4427-9C0A-76134B0D9FDB}" type="datetimeFigureOut">
              <a:rPr lang="es-ES" smtClean="0"/>
              <a:t>09/09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7CB82-52F1-45D7-918B-22DDAB191B7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83091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C2006-A67E-4427-9C0A-76134B0D9FDB}" type="datetimeFigureOut">
              <a:rPr lang="es-ES" smtClean="0"/>
              <a:t>09/09/20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7CB82-52F1-45D7-918B-22DDAB191B7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8663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C2006-A67E-4427-9C0A-76134B0D9FDB}" type="datetimeFigureOut">
              <a:rPr lang="es-ES" smtClean="0"/>
              <a:t>09/09/20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7CB82-52F1-45D7-918B-22DDAB191B7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79510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C2006-A67E-4427-9C0A-76134B0D9FDB}" type="datetimeFigureOut">
              <a:rPr lang="es-ES" smtClean="0"/>
              <a:t>09/09/20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7CB82-52F1-45D7-918B-22DDAB191B7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5894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C2006-A67E-4427-9C0A-76134B0D9FDB}" type="datetimeFigureOut">
              <a:rPr lang="es-ES" smtClean="0"/>
              <a:t>09/09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7CB82-52F1-45D7-918B-22DDAB191B7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07615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C2006-A67E-4427-9C0A-76134B0D9FDB}" type="datetimeFigureOut">
              <a:rPr lang="es-ES" smtClean="0"/>
              <a:t>09/09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7CB82-52F1-45D7-918B-22DDAB191B7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7094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0C2006-A67E-4427-9C0A-76134B0D9FDB}" type="datetimeFigureOut">
              <a:rPr lang="es-ES" smtClean="0"/>
              <a:t>09/09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C7CB82-52F1-45D7-918B-22DDAB191B7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93989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878977" y="781313"/>
            <a:ext cx="41667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 smtClean="0"/>
              <a:t>Supplemental</a:t>
            </a:r>
            <a:r>
              <a:rPr lang="es-ES" dirty="0" smtClean="0"/>
              <a:t> </a:t>
            </a:r>
            <a:r>
              <a:rPr lang="es-ES" dirty="0" err="1" smtClean="0"/>
              <a:t>Table</a:t>
            </a:r>
            <a:r>
              <a:rPr lang="es-ES" smtClean="0"/>
              <a:t> </a:t>
            </a:r>
            <a:r>
              <a:rPr lang="es-ES" smtClean="0"/>
              <a:t>S2</a:t>
            </a:r>
            <a:r>
              <a:rPr lang="es-ES" dirty="0" smtClean="0"/>
              <a:t>. </a:t>
            </a:r>
            <a:r>
              <a:rPr lang="es-ES" dirty="0" err="1" smtClean="0"/>
              <a:t>Reactome</a:t>
            </a:r>
            <a:r>
              <a:rPr lang="es-ES" dirty="0" smtClean="0"/>
              <a:t> </a:t>
            </a:r>
            <a:r>
              <a:rPr lang="es-ES" dirty="0" err="1" smtClean="0"/>
              <a:t>analysis</a:t>
            </a:r>
            <a:endParaRPr lang="es-ES" dirty="0"/>
          </a:p>
        </p:txBody>
      </p:sp>
      <p:pic>
        <p:nvPicPr>
          <p:cNvPr id="5" name="Imagen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8421" y="1150645"/>
            <a:ext cx="10675158" cy="4556709"/>
          </a:xfrm>
          <a:prstGeom prst="rect">
            <a:avLst/>
          </a:prstGeom>
        </p:spPr>
      </p:pic>
      <p:sp>
        <p:nvSpPr>
          <p:cNvPr id="3" name="Rectángulo 2"/>
          <p:cNvSpPr/>
          <p:nvPr/>
        </p:nvSpPr>
        <p:spPr>
          <a:xfrm>
            <a:off x="613719" y="5879296"/>
            <a:ext cx="11100486" cy="6850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</a:t>
            </a:r>
            <a:r>
              <a:rPr lang="en-US" altLang="zh-CN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en-US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actome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alysis of the proteins from in table 1. p-values are corrected for the multiple testing (</a:t>
            </a:r>
            <a:r>
              <a:rPr lang="en-US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njamini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–Hochberg procedure) (see material and methods) FDR, False discovery rate.</a:t>
            </a:r>
            <a:endParaRPr lang="es-ES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27517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E85452EC636355489586A29E74C067E0" ma:contentTypeVersion="14" ma:contentTypeDescription="Crear nuevo documento." ma:contentTypeScope="" ma:versionID="a2f8d9df5a0cbb78b07a8333a64a20fb">
  <xsd:schema xmlns:xsd="http://www.w3.org/2001/XMLSchema" xmlns:xs="http://www.w3.org/2001/XMLSchema" xmlns:p="http://schemas.microsoft.com/office/2006/metadata/properties" xmlns:ns3="c4402ada-99e8-444f-8592-ad72aa1a8c45" xmlns:ns4="7a3c92dd-5742-435a-8538-c47719897f54" targetNamespace="http://schemas.microsoft.com/office/2006/metadata/properties" ma:root="true" ma:fieldsID="07cc8102d82935fb157d6b6259f69125" ns3:_="" ns4:_="">
    <xsd:import namespace="c4402ada-99e8-444f-8592-ad72aa1a8c45"/>
    <xsd:import namespace="7a3c92dd-5742-435a-8538-c47719897f5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4402ada-99e8-444f-8592-ad72aa1a8c4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a3c92dd-5742-435a-8538-c47719897f54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1A178422-EBD4-40B9-AF3E-560B72BF1CEF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5CCB220F-5A66-4B56-AF25-7494818411D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4402ada-99e8-444f-8592-ad72aa1a8c45"/>
    <ds:schemaRef ds:uri="7a3c92dd-5742-435a-8538-c47719897f5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52BF01AF-A7D0-4D50-AECE-E834CB2717F0}">
  <ds:schemaRefs>
    <ds:schemaRef ds:uri="c4402ada-99e8-444f-8592-ad72aa1a8c45"/>
    <ds:schemaRef ds:uri="http://purl.org/dc/dcmitype/"/>
    <ds:schemaRef ds:uri="7a3c92dd-5742-435a-8538-c47719897f54"/>
    <ds:schemaRef ds:uri="http://purl.org/dc/elements/1.1/"/>
    <ds:schemaRef ds:uri="http://schemas.microsoft.com/office/2006/documentManagement/types"/>
    <ds:schemaRef ds:uri="http://schemas.microsoft.com/office/infopath/2007/PartnerControls"/>
    <ds:schemaRef ds:uri="http://purl.org/dc/terms/"/>
    <ds:schemaRef ds:uri="http://schemas.openxmlformats.org/package/2006/metadata/core-properties"/>
    <ds:schemaRef ds:uri="http://schemas.microsoft.com/office/2006/metadata/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80</TotalTime>
  <Words>81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Ramón Peinado Mena</dc:creator>
  <cp:lastModifiedBy>Microsoft account</cp:lastModifiedBy>
  <cp:revision>11</cp:revision>
  <dcterms:created xsi:type="dcterms:W3CDTF">2021-06-22T10:17:38Z</dcterms:created>
  <dcterms:modified xsi:type="dcterms:W3CDTF">2021-09-09T12:23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85452EC636355489586A29E74C067E0</vt:lpwstr>
  </property>
</Properties>
</file>